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7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3" autoAdjust="0"/>
    <p:restoredTop sz="94660"/>
  </p:normalViewPr>
  <p:slideViewPr>
    <p:cSldViewPr snapToGrid="0">
      <p:cViewPr>
        <p:scale>
          <a:sx n="75" d="100"/>
          <a:sy n="75" d="100"/>
        </p:scale>
        <p:origin x="538" y="8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wmf"/><Relationship Id="rId1" Type="http://schemas.openxmlformats.org/officeDocument/2006/relationships/image" Target="../media/image1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5853501-E25A-4FE2-BFC4-C820FC4F3B0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2B0569B8-F7D2-45D2-AA94-AC60616EA92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7399214-0941-4968-9999-E68DEB2205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F8034-0BCB-4EC5-803B-33F72D20B0D9}" type="datetimeFigureOut">
              <a:rPr lang="zh-CN" altLang="en-US" smtClean="0"/>
              <a:t>2024/7/2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30F0B1F-009B-4FBD-9371-688917C81F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6FA73F5-F609-457C-8B23-D932DF3DBA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A8B85-BE93-46D9-B26A-3FD474B123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819490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2C676BA-A4BE-406A-ABCB-84BE143199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C1D2784-DD1F-43DB-8CAF-0D730302668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05ADF00-FE7B-469F-8397-115C1CDF09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F8034-0BCB-4EC5-803B-33F72D20B0D9}" type="datetimeFigureOut">
              <a:rPr lang="zh-CN" altLang="en-US" smtClean="0"/>
              <a:t>2024/7/2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0BE65BA-8A64-4895-957D-3DCCDD8406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7A8EC03-1E6E-4981-B635-0A94C86C47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A8B85-BE93-46D9-B26A-3FD474B123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97436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2DD3405B-E95E-43B5-9C23-E511F6060A7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E330135-E891-43A5-8EA4-2AF1C6E5E20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9F688F0-14C6-45FC-AD91-DE3CC5F589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F8034-0BCB-4EC5-803B-33F72D20B0D9}" type="datetimeFigureOut">
              <a:rPr lang="zh-CN" altLang="en-US" smtClean="0"/>
              <a:t>2024/7/2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B003A9B-434C-428D-8B8C-A92935AD09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E348C60-AC1D-4F69-9A0A-917BE89EEC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A8B85-BE93-46D9-B26A-3FD474B123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541370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8BD3B1C-995B-45A9-A30B-235DBA65BD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B21D068-77AA-47F9-BEE6-3A5CFF96B13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5026BFD-20C9-40FC-97F6-809D4134FF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F8034-0BCB-4EC5-803B-33F72D20B0D9}" type="datetimeFigureOut">
              <a:rPr lang="zh-CN" altLang="en-US" smtClean="0"/>
              <a:t>2024/7/2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662EC6F-B0CD-4D16-BCD4-5F363E3215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4AC1C3B-AD12-4B69-BB66-8966E61ECC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A8B85-BE93-46D9-B26A-3FD474B123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61840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00DD8DA-3BCA-4C71-938B-AE1F68D4B1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266C985-A8C9-4C7E-9F3F-709B2DDC0B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CE0F55B-3513-44EE-8282-7B224ED7D2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F8034-0BCB-4EC5-803B-33F72D20B0D9}" type="datetimeFigureOut">
              <a:rPr lang="zh-CN" altLang="en-US" smtClean="0"/>
              <a:t>2024/7/2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F3B0D36-1216-4005-AC87-27E1E95CC1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76871D3-F0EF-4265-9B55-DAE9A36618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A8B85-BE93-46D9-B26A-3FD474B123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651766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FCA3C8B-46F7-4501-BEA9-11C08099C3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E517EF5-4A96-4E9C-8254-F7FF3571C66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E6EF67F-DE49-421D-AC40-29022AB7895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98EA292-5FDA-475A-81C4-5AB5DA0BB7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F8034-0BCB-4EC5-803B-33F72D20B0D9}" type="datetimeFigureOut">
              <a:rPr lang="zh-CN" altLang="en-US" smtClean="0"/>
              <a:t>2024/7/2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40D9FF1-98FA-466D-A5DF-07C3F93898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A0053D9-ACA5-4823-B5D3-1C6FDDF420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A8B85-BE93-46D9-B26A-3FD474B123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281013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B674E4D-2FEB-403F-AE7C-BE01D92123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FF6996E-8761-4F9B-98DC-6AB021B07F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7746628-FACC-4250-AA52-B6BB2CD3B06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13C00F46-EAD6-41D1-A3A3-D464E19B5B3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28009C95-C6C6-46C2-B108-DF8D1EE6CF9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ADAFFC2A-CBCD-44CC-9FA7-D163314149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F8034-0BCB-4EC5-803B-33F72D20B0D9}" type="datetimeFigureOut">
              <a:rPr lang="zh-CN" altLang="en-US" smtClean="0"/>
              <a:t>2024/7/26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95F97226-4240-4A49-BD2D-EE4AAE8802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CAAF969D-0A41-478E-B9F2-5E7E07ED10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A8B85-BE93-46D9-B26A-3FD474B123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697184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E69B957-397F-4410-9193-F8FD7B7669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3BC14F5F-6838-42E8-B865-8D7B1F9798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F8034-0BCB-4EC5-803B-33F72D20B0D9}" type="datetimeFigureOut">
              <a:rPr lang="zh-CN" altLang="en-US" smtClean="0"/>
              <a:t>2024/7/26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74F7FD86-8103-4090-AB80-C51917297C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9F2D7B19-29BC-44C8-89FC-48768EFB19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A8B85-BE93-46D9-B26A-3FD474B123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644188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90971AF2-93FA-4ECA-803D-68947C22F2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F8034-0BCB-4EC5-803B-33F72D20B0D9}" type="datetimeFigureOut">
              <a:rPr lang="zh-CN" altLang="en-US" smtClean="0"/>
              <a:t>2024/7/26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839C4073-0656-41B1-80EF-DBB19E7DA5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7F4C6FB7-F412-4AB7-90A6-8357821042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A8B85-BE93-46D9-B26A-3FD474B123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508705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EFA499B-22A9-4DCD-809C-CB3D5BE6AD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9879E29-AB98-49DC-9BEF-F30C1FCBF7D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83D7ABF-5C6F-47FC-9AB5-6210A90C59B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91B8433-29D0-4690-A73D-9F932FE76D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F8034-0BCB-4EC5-803B-33F72D20B0D9}" type="datetimeFigureOut">
              <a:rPr lang="zh-CN" altLang="en-US" smtClean="0"/>
              <a:t>2024/7/2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A81F950-EC88-476F-9663-3A9D60F640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6F03F13-E919-4CB9-90C5-C10505B62F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A8B85-BE93-46D9-B26A-3FD474B123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819856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0B70B86-465B-4C1D-8EFF-777181E833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8A36CE40-B452-4F8D-9135-EE1A0295F58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F9BD9A6-02BE-49D5-9B99-854BAB888BE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BF7E898-7240-48CC-9133-407D707DCC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F8034-0BCB-4EC5-803B-33F72D20B0D9}" type="datetimeFigureOut">
              <a:rPr lang="zh-CN" altLang="en-US" smtClean="0"/>
              <a:t>2024/7/2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35D8686-50DE-49EE-92FF-0F69A7DF1C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C434398-86AA-409D-A22C-04136D3D36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A8B85-BE93-46D9-B26A-3FD474B123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06211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61DB2059-AACB-4710-9DFF-353C26DBBC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51C4340-B599-4AFB-88B5-4D7D05CFBCD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AE68E71-54DF-4218-ABC1-5ADF5DCAA8A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8F8034-0BCB-4EC5-803B-33F72D20B0D9}" type="datetimeFigureOut">
              <a:rPr lang="zh-CN" altLang="en-US" smtClean="0"/>
              <a:t>2024/7/2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9B49E01-18C0-48C8-A447-6CBBE3CB539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9139BDC-BFEA-44C1-A24A-D8F94971FB1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7A8B85-BE93-46D9-B26A-3FD474B123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59450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w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w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对象 4">
            <a:extLst>
              <a:ext uri="{FF2B5EF4-FFF2-40B4-BE49-F238E27FC236}">
                <a16:creationId xmlns:a16="http://schemas.microsoft.com/office/drawing/2014/main" id="{A0E7A7FB-80ED-4A62-9CD6-DB338BFFF32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82346470"/>
              </p:ext>
            </p:extLst>
          </p:nvPr>
        </p:nvGraphicFramePr>
        <p:xfrm>
          <a:off x="2232322" y="1680495"/>
          <a:ext cx="6221241" cy="149584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1" r:id="rId3" imgW="8926920" imgH="2145960" progId="">
                  <p:embed/>
                </p:oleObj>
              </mc:Choice>
              <mc:Fallback>
                <p:oleObj r:id="rId3" imgW="8926920" imgH="214596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232322" y="1680495"/>
                        <a:ext cx="6221241" cy="149584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文本框 5">
            <a:extLst>
              <a:ext uri="{FF2B5EF4-FFF2-40B4-BE49-F238E27FC236}">
                <a16:creationId xmlns:a16="http://schemas.microsoft.com/office/drawing/2014/main" id="{64C3481E-A334-4F5A-8773-6A774D737328}"/>
              </a:ext>
            </a:extLst>
          </p:cNvPr>
          <p:cNvSpPr txBox="1"/>
          <p:nvPr/>
        </p:nvSpPr>
        <p:spPr>
          <a:xfrm>
            <a:off x="187592" y="2153688"/>
            <a:ext cx="118711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p-Smad3</a:t>
            </a:r>
          </a:p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(52KD)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D5D7E4BD-F989-4812-9846-B86A3AB538F6}"/>
              </a:ext>
            </a:extLst>
          </p:cNvPr>
          <p:cNvSpPr txBox="1"/>
          <p:nvPr/>
        </p:nvSpPr>
        <p:spPr>
          <a:xfrm>
            <a:off x="187592" y="3957528"/>
            <a:ext cx="118711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CTB</a:t>
            </a:r>
          </a:p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(43KD)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8D84C47B-4042-4B18-B724-2179B2653CB1}"/>
              </a:ext>
            </a:extLst>
          </p:cNvPr>
          <p:cNvSpPr txBox="1"/>
          <p:nvPr/>
        </p:nvSpPr>
        <p:spPr>
          <a:xfrm>
            <a:off x="451416" y="134127"/>
            <a:ext cx="34468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ull unedited gel for Figure 2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1" name="对象 10">
            <a:extLst>
              <a:ext uri="{FF2B5EF4-FFF2-40B4-BE49-F238E27FC236}">
                <a16:creationId xmlns:a16="http://schemas.microsoft.com/office/drawing/2014/main" id="{640E4804-063B-4120-A1E7-56EFF10D619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98949172"/>
              </p:ext>
            </p:extLst>
          </p:nvPr>
        </p:nvGraphicFramePr>
        <p:xfrm>
          <a:off x="2140771" y="3681664"/>
          <a:ext cx="5819917" cy="207640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2" r:id="rId5" imgW="8330040" imgH="2971080" progId="">
                  <p:embed/>
                </p:oleObj>
              </mc:Choice>
              <mc:Fallback>
                <p:oleObj r:id="rId5" imgW="8330040" imgH="297108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140771" y="3681664"/>
                        <a:ext cx="5819917" cy="207640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矩形: 圆角 11">
            <a:extLst>
              <a:ext uri="{FF2B5EF4-FFF2-40B4-BE49-F238E27FC236}">
                <a16:creationId xmlns:a16="http://schemas.microsoft.com/office/drawing/2014/main" id="{78CA7A9D-B2BD-40AA-ACC8-D61F2192B94E}"/>
              </a:ext>
            </a:extLst>
          </p:cNvPr>
          <p:cNvSpPr/>
          <p:nvPr/>
        </p:nvSpPr>
        <p:spPr>
          <a:xfrm>
            <a:off x="4127757" y="1797183"/>
            <a:ext cx="1716505" cy="1050758"/>
          </a:xfrm>
          <a:prstGeom prst="round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矩形: 圆角 13">
            <a:extLst>
              <a:ext uri="{FF2B5EF4-FFF2-40B4-BE49-F238E27FC236}">
                <a16:creationId xmlns:a16="http://schemas.microsoft.com/office/drawing/2014/main" id="{BDC7242E-BEDB-461D-BBB5-0CFF0BEAF324}"/>
              </a:ext>
            </a:extLst>
          </p:cNvPr>
          <p:cNvSpPr/>
          <p:nvPr/>
        </p:nvSpPr>
        <p:spPr>
          <a:xfrm>
            <a:off x="3887125" y="4194486"/>
            <a:ext cx="2149643" cy="1050758"/>
          </a:xfrm>
          <a:prstGeom prst="round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02AFDACE-DE3B-4D73-9214-695F65366C8A}"/>
              </a:ext>
            </a:extLst>
          </p:cNvPr>
          <p:cNvSpPr txBox="1"/>
          <p:nvPr/>
        </p:nvSpPr>
        <p:spPr>
          <a:xfrm>
            <a:off x="1518456" y="1784356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等腰三角形 2">
            <a:extLst>
              <a:ext uri="{FF2B5EF4-FFF2-40B4-BE49-F238E27FC236}">
                <a16:creationId xmlns:a16="http://schemas.microsoft.com/office/drawing/2014/main" id="{19D31455-7901-4B4F-A8AE-827B260A8277}"/>
              </a:ext>
            </a:extLst>
          </p:cNvPr>
          <p:cNvSpPr/>
          <p:nvPr/>
        </p:nvSpPr>
        <p:spPr>
          <a:xfrm rot="5400000">
            <a:off x="1952390" y="1923302"/>
            <a:ext cx="91440" cy="91440"/>
          </a:xfrm>
          <a:prstGeom prst="triangle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组合 3">
            <a:extLst>
              <a:ext uri="{FF2B5EF4-FFF2-40B4-BE49-F238E27FC236}">
                <a16:creationId xmlns:a16="http://schemas.microsoft.com/office/drawing/2014/main" id="{F3027972-76CC-4D1E-928D-49D0698D7C2D}"/>
              </a:ext>
            </a:extLst>
          </p:cNvPr>
          <p:cNvGrpSpPr/>
          <p:nvPr/>
        </p:nvGrpSpPr>
        <p:grpSpPr>
          <a:xfrm>
            <a:off x="1518456" y="2251716"/>
            <a:ext cx="525374" cy="369332"/>
            <a:chOff x="2026456" y="2251716"/>
            <a:chExt cx="525374" cy="369332"/>
          </a:xfrm>
        </p:grpSpPr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288E5278-1271-474B-B615-23DBE5ADC792}"/>
                </a:ext>
              </a:extLst>
            </p:cNvPr>
            <p:cNvSpPr txBox="1"/>
            <p:nvPr/>
          </p:nvSpPr>
          <p:spPr>
            <a:xfrm>
              <a:off x="2026456" y="2251716"/>
              <a:ext cx="4411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等腰三角形 14">
              <a:extLst>
                <a:ext uri="{FF2B5EF4-FFF2-40B4-BE49-F238E27FC236}">
                  <a16:creationId xmlns:a16="http://schemas.microsoft.com/office/drawing/2014/main" id="{D140DF2B-5B3E-4448-9741-EADAF6F3F465}"/>
                </a:ext>
              </a:extLst>
            </p:cNvPr>
            <p:cNvSpPr/>
            <p:nvPr/>
          </p:nvSpPr>
          <p:spPr>
            <a:xfrm rot="5400000">
              <a:off x="2460390" y="2390662"/>
              <a:ext cx="91440" cy="91440"/>
            </a:xfrm>
            <a:prstGeom prst="triangle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6" name="组合 15">
            <a:extLst>
              <a:ext uri="{FF2B5EF4-FFF2-40B4-BE49-F238E27FC236}">
                <a16:creationId xmlns:a16="http://schemas.microsoft.com/office/drawing/2014/main" id="{EA972FE1-1198-4AA0-99E0-DA6E64DD9BAD}"/>
              </a:ext>
            </a:extLst>
          </p:cNvPr>
          <p:cNvGrpSpPr/>
          <p:nvPr/>
        </p:nvGrpSpPr>
        <p:grpSpPr>
          <a:xfrm>
            <a:off x="1518456" y="2719076"/>
            <a:ext cx="525374" cy="369332"/>
            <a:chOff x="2026456" y="2251716"/>
            <a:chExt cx="525374" cy="369332"/>
          </a:xfrm>
        </p:grpSpPr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AA9AB63C-E605-4DFB-9FBF-858BBE074017}"/>
                </a:ext>
              </a:extLst>
            </p:cNvPr>
            <p:cNvSpPr txBox="1"/>
            <p:nvPr/>
          </p:nvSpPr>
          <p:spPr>
            <a:xfrm>
              <a:off x="2026456" y="2251716"/>
              <a:ext cx="4411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等腰三角形 17">
              <a:extLst>
                <a:ext uri="{FF2B5EF4-FFF2-40B4-BE49-F238E27FC236}">
                  <a16:creationId xmlns:a16="http://schemas.microsoft.com/office/drawing/2014/main" id="{8906CED4-2A7C-49B2-847C-6E51A3A8766A}"/>
                </a:ext>
              </a:extLst>
            </p:cNvPr>
            <p:cNvSpPr/>
            <p:nvPr/>
          </p:nvSpPr>
          <p:spPr>
            <a:xfrm rot="5400000">
              <a:off x="2460390" y="2390662"/>
              <a:ext cx="91440" cy="91440"/>
            </a:xfrm>
            <a:prstGeom prst="triangle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7" name="文本框 26">
            <a:extLst>
              <a:ext uri="{FF2B5EF4-FFF2-40B4-BE49-F238E27FC236}">
                <a16:creationId xmlns:a16="http://schemas.microsoft.com/office/drawing/2014/main" id="{8BAB45FE-3D66-44D6-B291-CEF116DE1F29}"/>
              </a:ext>
            </a:extLst>
          </p:cNvPr>
          <p:cNvSpPr txBox="1"/>
          <p:nvPr/>
        </p:nvSpPr>
        <p:spPr>
          <a:xfrm>
            <a:off x="1518456" y="4194486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等腰三角形 27">
            <a:extLst>
              <a:ext uri="{FF2B5EF4-FFF2-40B4-BE49-F238E27FC236}">
                <a16:creationId xmlns:a16="http://schemas.microsoft.com/office/drawing/2014/main" id="{CCD7633E-9567-461F-A5CF-1B683136A432}"/>
              </a:ext>
            </a:extLst>
          </p:cNvPr>
          <p:cNvSpPr/>
          <p:nvPr/>
        </p:nvSpPr>
        <p:spPr>
          <a:xfrm rot="5400000">
            <a:off x="1952390" y="4333432"/>
            <a:ext cx="91440" cy="91440"/>
          </a:xfrm>
          <a:prstGeom prst="triangle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9" name="组合 28">
            <a:extLst>
              <a:ext uri="{FF2B5EF4-FFF2-40B4-BE49-F238E27FC236}">
                <a16:creationId xmlns:a16="http://schemas.microsoft.com/office/drawing/2014/main" id="{74449FA1-0C33-42A3-AC55-72BCDBF4E88E}"/>
              </a:ext>
            </a:extLst>
          </p:cNvPr>
          <p:cNvGrpSpPr/>
          <p:nvPr/>
        </p:nvGrpSpPr>
        <p:grpSpPr>
          <a:xfrm>
            <a:off x="1518456" y="4783455"/>
            <a:ext cx="525374" cy="369332"/>
            <a:chOff x="2026456" y="2251716"/>
            <a:chExt cx="525374" cy="369332"/>
          </a:xfrm>
        </p:grpSpPr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45D65D13-BD7B-45FE-AD6A-5A6842A9B281}"/>
                </a:ext>
              </a:extLst>
            </p:cNvPr>
            <p:cNvSpPr txBox="1"/>
            <p:nvPr/>
          </p:nvSpPr>
          <p:spPr>
            <a:xfrm>
              <a:off x="2026456" y="2251716"/>
              <a:ext cx="4411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等腰三角形 30">
              <a:extLst>
                <a:ext uri="{FF2B5EF4-FFF2-40B4-BE49-F238E27FC236}">
                  <a16:creationId xmlns:a16="http://schemas.microsoft.com/office/drawing/2014/main" id="{9E770569-4838-4E49-AEB1-74AF92E75AF4}"/>
                </a:ext>
              </a:extLst>
            </p:cNvPr>
            <p:cNvSpPr/>
            <p:nvPr/>
          </p:nvSpPr>
          <p:spPr>
            <a:xfrm rot="5400000">
              <a:off x="2460390" y="2390662"/>
              <a:ext cx="91440" cy="91440"/>
            </a:xfrm>
            <a:prstGeom prst="triangle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2" name="组合 31">
            <a:extLst>
              <a:ext uri="{FF2B5EF4-FFF2-40B4-BE49-F238E27FC236}">
                <a16:creationId xmlns:a16="http://schemas.microsoft.com/office/drawing/2014/main" id="{120C7B7E-AEB0-48BC-832F-A93DC129979E}"/>
              </a:ext>
            </a:extLst>
          </p:cNvPr>
          <p:cNvGrpSpPr/>
          <p:nvPr/>
        </p:nvGrpSpPr>
        <p:grpSpPr>
          <a:xfrm>
            <a:off x="1518456" y="5372425"/>
            <a:ext cx="525374" cy="369332"/>
            <a:chOff x="2026456" y="2251716"/>
            <a:chExt cx="525374" cy="369332"/>
          </a:xfrm>
        </p:grpSpPr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FD57B884-352F-4AE8-BCB7-98EAC8EF0E88}"/>
                </a:ext>
              </a:extLst>
            </p:cNvPr>
            <p:cNvSpPr txBox="1"/>
            <p:nvPr/>
          </p:nvSpPr>
          <p:spPr>
            <a:xfrm>
              <a:off x="2026456" y="2251716"/>
              <a:ext cx="4411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等腰三角形 33">
              <a:extLst>
                <a:ext uri="{FF2B5EF4-FFF2-40B4-BE49-F238E27FC236}">
                  <a16:creationId xmlns:a16="http://schemas.microsoft.com/office/drawing/2014/main" id="{A17F265A-6761-438F-BE05-6426DE8169B1}"/>
                </a:ext>
              </a:extLst>
            </p:cNvPr>
            <p:cNvSpPr/>
            <p:nvPr/>
          </p:nvSpPr>
          <p:spPr>
            <a:xfrm rot="5400000">
              <a:off x="2460390" y="2390662"/>
              <a:ext cx="91440" cy="91440"/>
            </a:xfrm>
            <a:prstGeom prst="triangle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0004179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676A7009-546B-4AAB-8AFE-56C71CE3C41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69295" y="1599127"/>
            <a:ext cx="5705475" cy="1733550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B1338643-D0A0-4D87-80BF-8F873B58443F}"/>
              </a:ext>
            </a:extLst>
          </p:cNvPr>
          <p:cNvSpPr txBox="1"/>
          <p:nvPr/>
        </p:nvSpPr>
        <p:spPr>
          <a:xfrm>
            <a:off x="1037977" y="2088449"/>
            <a:ext cx="118711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p-Smad2</a:t>
            </a:r>
          </a:p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(60KD)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D5D7E4BD-F989-4812-9846-B86A3AB538F6}"/>
              </a:ext>
            </a:extLst>
          </p:cNvPr>
          <p:cNvSpPr txBox="1"/>
          <p:nvPr/>
        </p:nvSpPr>
        <p:spPr>
          <a:xfrm>
            <a:off x="1037977" y="4420862"/>
            <a:ext cx="118711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CTB</a:t>
            </a:r>
          </a:p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(not given)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8D84C47B-4042-4B18-B724-2179B2653CB1}"/>
              </a:ext>
            </a:extLst>
          </p:cNvPr>
          <p:cNvSpPr txBox="1"/>
          <p:nvPr/>
        </p:nvSpPr>
        <p:spPr>
          <a:xfrm>
            <a:off x="451416" y="134127"/>
            <a:ext cx="34468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ull unedited gel for Figure 2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矩形: 圆角 12">
            <a:extLst>
              <a:ext uri="{FF2B5EF4-FFF2-40B4-BE49-F238E27FC236}">
                <a16:creationId xmlns:a16="http://schemas.microsoft.com/office/drawing/2014/main" id="{27D549F0-456F-49E1-88FF-8646189D6CDB}"/>
              </a:ext>
            </a:extLst>
          </p:cNvPr>
          <p:cNvSpPr/>
          <p:nvPr/>
        </p:nvSpPr>
        <p:spPr>
          <a:xfrm>
            <a:off x="5118304" y="1895295"/>
            <a:ext cx="1540042" cy="1050758"/>
          </a:xfrm>
          <a:prstGeom prst="round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16352F88-4432-424E-B6C6-2F31A89B1D8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69295" y="4389970"/>
            <a:ext cx="5534025" cy="1323975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6F2CF617-8795-4A92-8EB8-0503AA9B515C}"/>
              </a:ext>
            </a:extLst>
          </p:cNvPr>
          <p:cNvSpPr txBox="1"/>
          <p:nvPr/>
        </p:nvSpPr>
        <p:spPr>
          <a:xfrm>
            <a:off x="2290225" y="1784356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等腰三角形 10">
            <a:extLst>
              <a:ext uri="{FF2B5EF4-FFF2-40B4-BE49-F238E27FC236}">
                <a16:creationId xmlns:a16="http://schemas.microsoft.com/office/drawing/2014/main" id="{C9945045-9751-4221-BABB-67A0295E88C6}"/>
              </a:ext>
            </a:extLst>
          </p:cNvPr>
          <p:cNvSpPr/>
          <p:nvPr/>
        </p:nvSpPr>
        <p:spPr>
          <a:xfrm rot="5400000">
            <a:off x="2724159" y="1923302"/>
            <a:ext cx="91440" cy="91440"/>
          </a:xfrm>
          <a:prstGeom prst="triangle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" name="组合 11">
            <a:extLst>
              <a:ext uri="{FF2B5EF4-FFF2-40B4-BE49-F238E27FC236}">
                <a16:creationId xmlns:a16="http://schemas.microsoft.com/office/drawing/2014/main" id="{36EF010C-9FC0-4594-8E4B-E5E0F41E6CE1}"/>
              </a:ext>
            </a:extLst>
          </p:cNvPr>
          <p:cNvGrpSpPr/>
          <p:nvPr/>
        </p:nvGrpSpPr>
        <p:grpSpPr>
          <a:xfrm>
            <a:off x="2290225" y="2251716"/>
            <a:ext cx="525374" cy="369332"/>
            <a:chOff x="2026456" y="2251716"/>
            <a:chExt cx="525374" cy="369332"/>
          </a:xfrm>
        </p:grpSpPr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CFB4919A-16F1-4F92-8941-7BBD501703D5}"/>
                </a:ext>
              </a:extLst>
            </p:cNvPr>
            <p:cNvSpPr txBox="1"/>
            <p:nvPr/>
          </p:nvSpPr>
          <p:spPr>
            <a:xfrm>
              <a:off x="2026456" y="2251716"/>
              <a:ext cx="4411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等腰三角形 14">
              <a:extLst>
                <a:ext uri="{FF2B5EF4-FFF2-40B4-BE49-F238E27FC236}">
                  <a16:creationId xmlns:a16="http://schemas.microsoft.com/office/drawing/2014/main" id="{BFF28E8A-1B47-46F1-8FC7-6B25153CCA9D}"/>
                </a:ext>
              </a:extLst>
            </p:cNvPr>
            <p:cNvSpPr/>
            <p:nvPr/>
          </p:nvSpPr>
          <p:spPr>
            <a:xfrm rot="5400000">
              <a:off x="2460390" y="2390662"/>
              <a:ext cx="91440" cy="91440"/>
            </a:xfrm>
            <a:prstGeom prst="triangle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6" name="组合 15">
            <a:extLst>
              <a:ext uri="{FF2B5EF4-FFF2-40B4-BE49-F238E27FC236}">
                <a16:creationId xmlns:a16="http://schemas.microsoft.com/office/drawing/2014/main" id="{E5A99FF3-237D-4947-81FF-FEA1E251A0C5}"/>
              </a:ext>
            </a:extLst>
          </p:cNvPr>
          <p:cNvGrpSpPr/>
          <p:nvPr/>
        </p:nvGrpSpPr>
        <p:grpSpPr>
          <a:xfrm>
            <a:off x="2290225" y="2719076"/>
            <a:ext cx="525374" cy="369332"/>
            <a:chOff x="2026456" y="2251716"/>
            <a:chExt cx="525374" cy="369332"/>
          </a:xfrm>
        </p:grpSpPr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98C51F25-0F94-4EEC-B4C4-1B8D5A91E477}"/>
                </a:ext>
              </a:extLst>
            </p:cNvPr>
            <p:cNvSpPr txBox="1"/>
            <p:nvPr/>
          </p:nvSpPr>
          <p:spPr>
            <a:xfrm>
              <a:off x="2026456" y="2251716"/>
              <a:ext cx="4411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等腰三角形 17">
              <a:extLst>
                <a:ext uri="{FF2B5EF4-FFF2-40B4-BE49-F238E27FC236}">
                  <a16:creationId xmlns:a16="http://schemas.microsoft.com/office/drawing/2014/main" id="{24486750-9ADE-429D-BD85-48DA3D6ABB95}"/>
                </a:ext>
              </a:extLst>
            </p:cNvPr>
            <p:cNvSpPr/>
            <p:nvPr/>
          </p:nvSpPr>
          <p:spPr>
            <a:xfrm rot="5400000">
              <a:off x="2460390" y="2390662"/>
              <a:ext cx="91440" cy="91440"/>
            </a:xfrm>
            <a:prstGeom prst="triangle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" name="组合 3">
            <a:extLst>
              <a:ext uri="{FF2B5EF4-FFF2-40B4-BE49-F238E27FC236}">
                <a16:creationId xmlns:a16="http://schemas.microsoft.com/office/drawing/2014/main" id="{2715F8B0-EC68-4678-841F-07F1CB004B59}"/>
              </a:ext>
            </a:extLst>
          </p:cNvPr>
          <p:cNvGrpSpPr/>
          <p:nvPr/>
        </p:nvGrpSpPr>
        <p:grpSpPr>
          <a:xfrm>
            <a:off x="2290225" y="4443250"/>
            <a:ext cx="525374" cy="369332"/>
            <a:chOff x="2290225" y="4194486"/>
            <a:chExt cx="525374" cy="369332"/>
          </a:xfrm>
        </p:grpSpPr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FA56F191-2D72-44F0-A677-7C5F47A3B758}"/>
                </a:ext>
              </a:extLst>
            </p:cNvPr>
            <p:cNvSpPr txBox="1"/>
            <p:nvPr/>
          </p:nvSpPr>
          <p:spPr>
            <a:xfrm>
              <a:off x="2290225" y="4194486"/>
              <a:ext cx="4411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等腰三角形 19">
              <a:extLst>
                <a:ext uri="{FF2B5EF4-FFF2-40B4-BE49-F238E27FC236}">
                  <a16:creationId xmlns:a16="http://schemas.microsoft.com/office/drawing/2014/main" id="{427D74E7-2A51-4E93-99E0-8D4BC5CCD198}"/>
                </a:ext>
              </a:extLst>
            </p:cNvPr>
            <p:cNvSpPr/>
            <p:nvPr/>
          </p:nvSpPr>
          <p:spPr>
            <a:xfrm rot="5400000">
              <a:off x="2724159" y="4333432"/>
              <a:ext cx="91440" cy="91440"/>
            </a:xfrm>
            <a:prstGeom prst="triangle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1" name="组合 20">
            <a:extLst>
              <a:ext uri="{FF2B5EF4-FFF2-40B4-BE49-F238E27FC236}">
                <a16:creationId xmlns:a16="http://schemas.microsoft.com/office/drawing/2014/main" id="{21CD32EF-343B-4BE6-8507-E2B8710259DD}"/>
              </a:ext>
            </a:extLst>
          </p:cNvPr>
          <p:cNvGrpSpPr/>
          <p:nvPr/>
        </p:nvGrpSpPr>
        <p:grpSpPr>
          <a:xfrm>
            <a:off x="2290225" y="4874995"/>
            <a:ext cx="525374" cy="369332"/>
            <a:chOff x="2026456" y="2251716"/>
            <a:chExt cx="525374" cy="369332"/>
          </a:xfrm>
        </p:grpSpPr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1E3C1CF8-3E21-4D5B-90FB-1D846B4BF0D4}"/>
                </a:ext>
              </a:extLst>
            </p:cNvPr>
            <p:cNvSpPr txBox="1"/>
            <p:nvPr/>
          </p:nvSpPr>
          <p:spPr>
            <a:xfrm>
              <a:off x="2026456" y="2251716"/>
              <a:ext cx="4411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等腰三角形 22">
              <a:extLst>
                <a:ext uri="{FF2B5EF4-FFF2-40B4-BE49-F238E27FC236}">
                  <a16:creationId xmlns:a16="http://schemas.microsoft.com/office/drawing/2014/main" id="{03F22AF7-AFC7-4CC8-86F8-993C07F44F0B}"/>
                </a:ext>
              </a:extLst>
            </p:cNvPr>
            <p:cNvSpPr/>
            <p:nvPr/>
          </p:nvSpPr>
          <p:spPr>
            <a:xfrm rot="5400000">
              <a:off x="2460390" y="2390662"/>
              <a:ext cx="91440" cy="91440"/>
            </a:xfrm>
            <a:prstGeom prst="triangle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4" name="组合 23">
            <a:extLst>
              <a:ext uri="{FF2B5EF4-FFF2-40B4-BE49-F238E27FC236}">
                <a16:creationId xmlns:a16="http://schemas.microsoft.com/office/drawing/2014/main" id="{4B72AA53-7814-42DC-8572-42353DEA2113}"/>
              </a:ext>
            </a:extLst>
          </p:cNvPr>
          <p:cNvGrpSpPr/>
          <p:nvPr/>
        </p:nvGrpSpPr>
        <p:grpSpPr>
          <a:xfrm>
            <a:off x="2290225" y="5344613"/>
            <a:ext cx="525374" cy="369332"/>
            <a:chOff x="2026456" y="2251716"/>
            <a:chExt cx="525374" cy="369332"/>
          </a:xfrm>
        </p:grpSpPr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21D7E726-F44C-4092-9DBB-B284A2D54E82}"/>
                </a:ext>
              </a:extLst>
            </p:cNvPr>
            <p:cNvSpPr txBox="1"/>
            <p:nvPr/>
          </p:nvSpPr>
          <p:spPr>
            <a:xfrm>
              <a:off x="2026456" y="2251716"/>
              <a:ext cx="4411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等腰三角形 25">
              <a:extLst>
                <a:ext uri="{FF2B5EF4-FFF2-40B4-BE49-F238E27FC236}">
                  <a16:creationId xmlns:a16="http://schemas.microsoft.com/office/drawing/2014/main" id="{8DF2F15E-38D2-4787-9B4E-E6B5BB9F63D8}"/>
                </a:ext>
              </a:extLst>
            </p:cNvPr>
            <p:cNvSpPr/>
            <p:nvPr/>
          </p:nvSpPr>
          <p:spPr>
            <a:xfrm rot="5400000">
              <a:off x="2460390" y="2390662"/>
              <a:ext cx="91440" cy="91440"/>
            </a:xfrm>
            <a:prstGeom prst="triangle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4810921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48FA6080-290B-4A95-A64E-D8E975540C7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06344" y="3403371"/>
            <a:ext cx="7800975" cy="2057400"/>
          </a:xfrm>
          <a:prstGeom prst="rect">
            <a:avLst/>
          </a:prstGeom>
        </p:spPr>
      </p:pic>
      <p:pic>
        <p:nvPicPr>
          <p:cNvPr id="2" name="图片 1">
            <a:extLst>
              <a:ext uri="{FF2B5EF4-FFF2-40B4-BE49-F238E27FC236}">
                <a16:creationId xmlns:a16="http://schemas.microsoft.com/office/drawing/2014/main" id="{44313723-22F7-4DC0-9060-7442D111576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06344" y="870268"/>
            <a:ext cx="6232358" cy="1691875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64C3481E-A334-4F5A-8773-6A774D737328}"/>
              </a:ext>
            </a:extLst>
          </p:cNvPr>
          <p:cNvSpPr txBox="1"/>
          <p:nvPr/>
        </p:nvSpPr>
        <p:spPr>
          <a:xfrm>
            <a:off x="916005" y="1351583"/>
            <a:ext cx="118711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EPX</a:t>
            </a:r>
          </a:p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(55KD)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D5D7E4BD-F989-4812-9846-B86A3AB538F6}"/>
              </a:ext>
            </a:extLst>
          </p:cNvPr>
          <p:cNvSpPr txBox="1"/>
          <p:nvPr/>
        </p:nvSpPr>
        <p:spPr>
          <a:xfrm>
            <a:off x="916005" y="4030424"/>
            <a:ext cx="11871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CTB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8D84C47B-4042-4B18-B724-2179B2653CB1}"/>
              </a:ext>
            </a:extLst>
          </p:cNvPr>
          <p:cNvSpPr txBox="1"/>
          <p:nvPr/>
        </p:nvSpPr>
        <p:spPr>
          <a:xfrm>
            <a:off x="451416" y="134127"/>
            <a:ext cx="34468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ull unedited gel for Figure 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矩形: 圆角 11">
            <a:extLst>
              <a:ext uri="{FF2B5EF4-FFF2-40B4-BE49-F238E27FC236}">
                <a16:creationId xmlns:a16="http://schemas.microsoft.com/office/drawing/2014/main" id="{78CA7A9D-B2BD-40AA-ACC8-D61F2192B94E}"/>
              </a:ext>
            </a:extLst>
          </p:cNvPr>
          <p:cNvSpPr/>
          <p:nvPr/>
        </p:nvSpPr>
        <p:spPr>
          <a:xfrm>
            <a:off x="6506678" y="1190826"/>
            <a:ext cx="1828800" cy="1050758"/>
          </a:xfrm>
          <a:prstGeom prst="round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矩形: 圆角 13">
            <a:extLst>
              <a:ext uri="{FF2B5EF4-FFF2-40B4-BE49-F238E27FC236}">
                <a16:creationId xmlns:a16="http://schemas.microsoft.com/office/drawing/2014/main" id="{BDC7242E-BEDB-461D-BBB5-0CFF0BEAF324}"/>
              </a:ext>
            </a:extLst>
          </p:cNvPr>
          <p:cNvSpPr/>
          <p:nvPr/>
        </p:nvSpPr>
        <p:spPr>
          <a:xfrm>
            <a:off x="3872881" y="4137634"/>
            <a:ext cx="2008156" cy="1050758"/>
          </a:xfrm>
          <a:prstGeom prst="round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B72FEAE9-8123-4F33-8ECD-42F4908AD78F}"/>
              </a:ext>
            </a:extLst>
          </p:cNvPr>
          <p:cNvSpPr txBox="1"/>
          <p:nvPr/>
        </p:nvSpPr>
        <p:spPr>
          <a:xfrm>
            <a:off x="2103120" y="790731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等腰三角形 10">
            <a:extLst>
              <a:ext uri="{FF2B5EF4-FFF2-40B4-BE49-F238E27FC236}">
                <a16:creationId xmlns:a16="http://schemas.microsoft.com/office/drawing/2014/main" id="{BEA94518-73AA-4319-934B-69B4DA14391D}"/>
              </a:ext>
            </a:extLst>
          </p:cNvPr>
          <p:cNvSpPr/>
          <p:nvPr/>
        </p:nvSpPr>
        <p:spPr>
          <a:xfrm rot="5400000">
            <a:off x="2537054" y="929677"/>
            <a:ext cx="91440" cy="91440"/>
          </a:xfrm>
          <a:prstGeom prst="triangle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3" name="组合 12">
            <a:extLst>
              <a:ext uri="{FF2B5EF4-FFF2-40B4-BE49-F238E27FC236}">
                <a16:creationId xmlns:a16="http://schemas.microsoft.com/office/drawing/2014/main" id="{1CF99883-C5A9-4070-A0C1-BA917C27ACA9}"/>
              </a:ext>
            </a:extLst>
          </p:cNvPr>
          <p:cNvGrpSpPr/>
          <p:nvPr/>
        </p:nvGrpSpPr>
        <p:grpSpPr>
          <a:xfrm>
            <a:off x="2103120" y="1551191"/>
            <a:ext cx="525374" cy="369332"/>
            <a:chOff x="2026456" y="2251716"/>
            <a:chExt cx="525374" cy="369332"/>
          </a:xfrm>
        </p:grpSpPr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2FC6DBB2-90AA-429B-9AD3-4CF8A0243B1E}"/>
                </a:ext>
              </a:extLst>
            </p:cNvPr>
            <p:cNvSpPr txBox="1"/>
            <p:nvPr/>
          </p:nvSpPr>
          <p:spPr>
            <a:xfrm>
              <a:off x="2026456" y="2251716"/>
              <a:ext cx="4411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等腰三角形 15">
              <a:extLst>
                <a:ext uri="{FF2B5EF4-FFF2-40B4-BE49-F238E27FC236}">
                  <a16:creationId xmlns:a16="http://schemas.microsoft.com/office/drawing/2014/main" id="{D594406E-99F4-4E84-8BA0-64D2BFBDC2A9}"/>
                </a:ext>
              </a:extLst>
            </p:cNvPr>
            <p:cNvSpPr/>
            <p:nvPr/>
          </p:nvSpPr>
          <p:spPr>
            <a:xfrm rot="5400000">
              <a:off x="2460390" y="2390662"/>
              <a:ext cx="91440" cy="91440"/>
            </a:xfrm>
            <a:prstGeom prst="triangle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7" name="组合 16">
            <a:extLst>
              <a:ext uri="{FF2B5EF4-FFF2-40B4-BE49-F238E27FC236}">
                <a16:creationId xmlns:a16="http://schemas.microsoft.com/office/drawing/2014/main" id="{D31E02F3-12DB-4A59-8B68-9999912F4F11}"/>
              </a:ext>
            </a:extLst>
          </p:cNvPr>
          <p:cNvGrpSpPr/>
          <p:nvPr/>
        </p:nvGrpSpPr>
        <p:grpSpPr>
          <a:xfrm>
            <a:off x="2103120" y="2273579"/>
            <a:ext cx="525374" cy="369332"/>
            <a:chOff x="2026456" y="2251716"/>
            <a:chExt cx="525374" cy="369332"/>
          </a:xfrm>
        </p:grpSpPr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4A20EE5F-23C4-4C62-8CDE-4CCFEF65B2A3}"/>
                </a:ext>
              </a:extLst>
            </p:cNvPr>
            <p:cNvSpPr txBox="1"/>
            <p:nvPr/>
          </p:nvSpPr>
          <p:spPr>
            <a:xfrm>
              <a:off x="2026456" y="2251716"/>
              <a:ext cx="4411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等腰三角形 18">
              <a:extLst>
                <a:ext uri="{FF2B5EF4-FFF2-40B4-BE49-F238E27FC236}">
                  <a16:creationId xmlns:a16="http://schemas.microsoft.com/office/drawing/2014/main" id="{86D0AF0D-171B-4413-A4FA-D1183485AAF5}"/>
                </a:ext>
              </a:extLst>
            </p:cNvPr>
            <p:cNvSpPr/>
            <p:nvPr/>
          </p:nvSpPr>
          <p:spPr>
            <a:xfrm rot="5400000">
              <a:off x="2460390" y="2390662"/>
              <a:ext cx="91440" cy="91440"/>
            </a:xfrm>
            <a:prstGeom prst="triangle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0" name="组合 19">
            <a:extLst>
              <a:ext uri="{FF2B5EF4-FFF2-40B4-BE49-F238E27FC236}">
                <a16:creationId xmlns:a16="http://schemas.microsoft.com/office/drawing/2014/main" id="{18C63FB7-8707-48C5-8FC2-8A8AC6BF3781}"/>
              </a:ext>
            </a:extLst>
          </p:cNvPr>
          <p:cNvGrpSpPr/>
          <p:nvPr/>
        </p:nvGrpSpPr>
        <p:grpSpPr>
          <a:xfrm>
            <a:off x="2242045" y="4287029"/>
            <a:ext cx="525374" cy="369332"/>
            <a:chOff x="2290225" y="4194486"/>
            <a:chExt cx="525374" cy="369332"/>
          </a:xfrm>
        </p:grpSpPr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77485F8F-980A-4AB6-AAEF-C58624107BE8}"/>
                </a:ext>
              </a:extLst>
            </p:cNvPr>
            <p:cNvSpPr txBox="1"/>
            <p:nvPr/>
          </p:nvSpPr>
          <p:spPr>
            <a:xfrm>
              <a:off x="2290225" y="4194486"/>
              <a:ext cx="4411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等腰三角形 21">
              <a:extLst>
                <a:ext uri="{FF2B5EF4-FFF2-40B4-BE49-F238E27FC236}">
                  <a16:creationId xmlns:a16="http://schemas.microsoft.com/office/drawing/2014/main" id="{1E569A83-C1F9-49A6-9070-C350B6B27867}"/>
                </a:ext>
              </a:extLst>
            </p:cNvPr>
            <p:cNvSpPr/>
            <p:nvPr/>
          </p:nvSpPr>
          <p:spPr>
            <a:xfrm rot="5400000">
              <a:off x="2724159" y="4333432"/>
              <a:ext cx="91440" cy="91440"/>
            </a:xfrm>
            <a:prstGeom prst="triangle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3" name="组合 22">
            <a:extLst>
              <a:ext uri="{FF2B5EF4-FFF2-40B4-BE49-F238E27FC236}">
                <a16:creationId xmlns:a16="http://schemas.microsoft.com/office/drawing/2014/main" id="{FDE02B16-4C7A-4224-8A8C-530C2C2072C3}"/>
              </a:ext>
            </a:extLst>
          </p:cNvPr>
          <p:cNvGrpSpPr/>
          <p:nvPr/>
        </p:nvGrpSpPr>
        <p:grpSpPr>
          <a:xfrm>
            <a:off x="2242045" y="4507324"/>
            <a:ext cx="525374" cy="369332"/>
            <a:chOff x="2026456" y="2251716"/>
            <a:chExt cx="525374" cy="369332"/>
          </a:xfrm>
        </p:grpSpPr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131A9C4D-8F31-4E2A-AF53-DEDFBA428471}"/>
                </a:ext>
              </a:extLst>
            </p:cNvPr>
            <p:cNvSpPr txBox="1"/>
            <p:nvPr/>
          </p:nvSpPr>
          <p:spPr>
            <a:xfrm>
              <a:off x="2026456" y="2251716"/>
              <a:ext cx="4411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等腰三角形 24">
              <a:extLst>
                <a:ext uri="{FF2B5EF4-FFF2-40B4-BE49-F238E27FC236}">
                  <a16:creationId xmlns:a16="http://schemas.microsoft.com/office/drawing/2014/main" id="{3C5BF205-EAFE-4FEB-9E99-D8369170C347}"/>
                </a:ext>
              </a:extLst>
            </p:cNvPr>
            <p:cNvSpPr/>
            <p:nvPr/>
          </p:nvSpPr>
          <p:spPr>
            <a:xfrm rot="5400000">
              <a:off x="2460390" y="2390662"/>
              <a:ext cx="91440" cy="91440"/>
            </a:xfrm>
            <a:prstGeom prst="triangle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6" name="组合 25">
            <a:extLst>
              <a:ext uri="{FF2B5EF4-FFF2-40B4-BE49-F238E27FC236}">
                <a16:creationId xmlns:a16="http://schemas.microsoft.com/office/drawing/2014/main" id="{0FA89A30-2A45-49C3-892F-5B2094149038}"/>
              </a:ext>
            </a:extLst>
          </p:cNvPr>
          <p:cNvGrpSpPr/>
          <p:nvPr/>
        </p:nvGrpSpPr>
        <p:grpSpPr>
          <a:xfrm>
            <a:off x="2242045" y="4904603"/>
            <a:ext cx="525374" cy="369332"/>
            <a:chOff x="2026456" y="2251716"/>
            <a:chExt cx="525374" cy="369332"/>
          </a:xfrm>
        </p:grpSpPr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9417339E-54AA-4F16-9F87-444BA0661DA8}"/>
                </a:ext>
              </a:extLst>
            </p:cNvPr>
            <p:cNvSpPr txBox="1"/>
            <p:nvPr/>
          </p:nvSpPr>
          <p:spPr>
            <a:xfrm>
              <a:off x="2026456" y="2251716"/>
              <a:ext cx="4411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等腰三角形 27">
              <a:extLst>
                <a:ext uri="{FF2B5EF4-FFF2-40B4-BE49-F238E27FC236}">
                  <a16:creationId xmlns:a16="http://schemas.microsoft.com/office/drawing/2014/main" id="{262DC6A3-F948-47FA-B49D-C21642D90E59}"/>
                </a:ext>
              </a:extLst>
            </p:cNvPr>
            <p:cNvSpPr/>
            <p:nvPr/>
          </p:nvSpPr>
          <p:spPr>
            <a:xfrm rot="5400000">
              <a:off x="2460390" y="2390662"/>
              <a:ext cx="91440" cy="91440"/>
            </a:xfrm>
            <a:prstGeom prst="triangle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7152233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5</TotalTime>
  <Words>58</Words>
  <Application>Microsoft Office PowerPoint</Application>
  <PresentationFormat>宽屏</PresentationFormat>
  <Paragraphs>32</Paragraphs>
  <Slides>3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0</vt:i4>
      </vt:variant>
      <vt:variant>
        <vt:lpstr>幻灯片标题</vt:lpstr>
      </vt:variant>
      <vt:variant>
        <vt:i4>3</vt:i4>
      </vt:variant>
    </vt:vector>
  </HeadingPairs>
  <TitlesOfParts>
    <vt:vector size="7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</dc:creator>
  <cp:lastModifiedBy>admin</cp:lastModifiedBy>
  <cp:revision>8</cp:revision>
  <dcterms:created xsi:type="dcterms:W3CDTF">2024-03-16T14:31:57Z</dcterms:created>
  <dcterms:modified xsi:type="dcterms:W3CDTF">2024-07-26T13:11:20Z</dcterms:modified>
</cp:coreProperties>
</file>